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472" y="23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1016734" y="1064569"/>
          <a:ext cx="4824535" cy="4032470"/>
        </p:xfrm>
        <a:graphic>
          <a:graphicData uri="http://schemas.openxmlformats.org/drawingml/2006/table">
            <a:tbl>
              <a:tblPr/>
              <a:tblGrid>
                <a:gridCol w="1044114"/>
                <a:gridCol w="792088"/>
                <a:gridCol w="2988333"/>
              </a:tblGrid>
              <a:tr h="42435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ene ID </a:t>
                      </a:r>
                      <a:endParaRPr lang="zh-CN" sz="1200" b="1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ene </a:t>
                      </a:r>
                      <a:endParaRPr lang="zh-CN" sz="1200" b="1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Primer </a:t>
                      </a:r>
                      <a:r>
                        <a:rPr lang="en-US" sz="1200" b="1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sequence (5’ to</a:t>
                      </a:r>
                      <a:r>
                        <a:rPr lang="en-US" sz="1200" b="1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3’ )</a:t>
                      </a:r>
                      <a:endParaRPr lang="zh-CN" sz="1200" b="1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011888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MIP-3</a:t>
                      </a:r>
                      <a:r>
                        <a:rPr lang="el-GR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β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r>
                        <a:rPr lang="en-US" altLang="zh-CN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GAAGGCTTTCACGATGTTC</a:t>
                      </a: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altLang="zh-CN" sz="1200" kern="150" dirty="0">
                        <a:solidFill>
                          <a:srgbClr val="000000"/>
                        </a:solidFill>
                        <a:latin typeface="Arial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Reverse: </a:t>
                      </a:r>
                      <a:r>
                        <a:rPr lang="en-US" altLang="zh-CN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TTCAGCCTGCTGGTTCTCT</a:t>
                      </a: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altLang="zh-CN" sz="1200" kern="150" dirty="0">
                        <a:solidFill>
                          <a:srgbClr val="000000"/>
                        </a:solidFill>
                        <a:latin typeface="Arial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07719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err="1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CR7</a:t>
                      </a: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it-IT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AAAGCACAGCCTTCCTGTGT</a:t>
                      </a: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altLang="zh-CN" sz="1200" kern="150" dirty="0">
                        <a:solidFill>
                          <a:srgbClr val="000000"/>
                        </a:solidFill>
                        <a:latin typeface="Arial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it-IT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AGTCCACCGTGGTATTCTC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011331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MCP-5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altLang="zh-CN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CTGAAGATCACAGCTTCCC</a:t>
                      </a: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altLang="zh-CN" sz="1200" kern="150" dirty="0">
                        <a:solidFill>
                          <a:srgbClr val="000000"/>
                        </a:solidFill>
                        <a:latin typeface="Arial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altLang="zh-CN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GTCCTCAGGTATTGGCTGGA</a:t>
                      </a: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endParaRPr lang="zh-CN" altLang="zh-CN" sz="1200" kern="150" dirty="0">
                        <a:solidFill>
                          <a:srgbClr val="000000"/>
                        </a:solidFill>
                        <a:latin typeface="Arial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09915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err="1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CR2</a:t>
                      </a: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AGCACATGTGGTGAATCCAA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TGCCATCATAAAGGAGCCA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09911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err="1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XCR4</a:t>
                      </a: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TCCAGACCCCACTTCTTCA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AGTGACCCTCTGAGGCGTTT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09465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Ax</a:t>
                      </a:r>
                      <a:r>
                        <a:rPr lang="en-US" altLang="zh-CN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l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AGCACTGTGATGGTGGCT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CACAGTCTGCAAACTCCA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08610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MMP-2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ACGGCATCCAGGTTATCA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TGCAGGAGACAAGTTCTGGA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NM 013599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MMP-9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Forward:</a:t>
                      </a:r>
                      <a:r>
                        <a:rPr lang="en-US" altLang="zh-CN" sz="1200" kern="150" baseline="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GTGGTTCAGTTGTGGTGGT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5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kern="150" dirty="0" smtClean="0">
                          <a:solidFill>
                            <a:srgbClr val="000000"/>
                          </a:solidFill>
                          <a:latin typeface="Arial"/>
                          <a:ea typeface="+mn-ea"/>
                          <a:cs typeface="Tahoma"/>
                        </a:rPr>
                        <a:t>Reverse: </a:t>
                      </a:r>
                      <a:r>
                        <a:rPr lang="en-US" sz="1200" kern="150" dirty="0" err="1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CCCGCTGTATAGCTACCTCG</a:t>
                      </a:r>
                      <a:r>
                        <a:rPr lang="en-US" sz="1200" kern="150" dirty="0" smtClean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ahoma"/>
                        </a:rPr>
                        <a:t> </a:t>
                      </a:r>
                      <a:endParaRPr lang="zh-CN" sz="1200" kern="150" dirty="0">
                        <a:latin typeface="Calibri"/>
                        <a:ea typeface="宋体"/>
                        <a:cs typeface="Tahoma"/>
                      </a:endParaRPr>
                    </a:p>
                  </a:txBody>
                  <a:tcPr marL="30283" marR="30283" marT="39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44016" y="210499"/>
            <a:ext cx="270892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宋体" pitchFamily="2" charset="-122"/>
                <a:cs typeface="Arial" pitchFamily="34" charset="0"/>
              </a:rPr>
              <a:t>Supplemental information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44016" y="654006"/>
            <a:ext cx="350100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>
                <a:solidFill>
                  <a:srgbClr val="000000"/>
                </a:solidFill>
                <a:ea typeface="宋体" pitchFamily="2" charset="-122"/>
                <a:cs typeface="Arial" pitchFamily="34" charset="0"/>
              </a:rPr>
              <a:t>Table 1</a:t>
            </a:r>
            <a:r>
              <a:rPr lang="en-US" altLang="zh-CN" sz="1600" b="1" dirty="0" smtClean="0">
                <a:solidFill>
                  <a:srgbClr val="000000"/>
                </a:solidFill>
                <a:ea typeface="宋体" pitchFamily="2" charset="-122"/>
                <a:cs typeface="Arial" pitchFamily="34" charset="0"/>
              </a:rPr>
              <a:t>: </a:t>
            </a:r>
            <a:r>
              <a:rPr lang="en-US" altLang="zh-CN" sz="1600" dirty="0" smtClean="0">
                <a:solidFill>
                  <a:srgbClr val="000000"/>
                </a:solidFill>
                <a:ea typeface="宋体" pitchFamily="2" charset="-122"/>
                <a:cs typeface="Arial" pitchFamily="34" charset="0"/>
              </a:rPr>
              <a:t>Primers used for real-time PCR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双光子-补充.tif"/>
          <p:cNvPicPr>
            <a:picLocks noChangeAspect="1"/>
          </p:cNvPicPr>
          <p:nvPr/>
        </p:nvPicPr>
        <p:blipFill>
          <a:blip r:embed="rId2" cstate="print"/>
          <a:srcRect b="94677"/>
          <a:stretch>
            <a:fillRect/>
          </a:stretch>
        </p:blipFill>
        <p:spPr>
          <a:xfrm>
            <a:off x="625160" y="1548000"/>
            <a:ext cx="5607681" cy="287432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44016" y="654006"/>
            <a:ext cx="659735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>
                <a:solidFill>
                  <a:srgbClr val="000000"/>
                </a:solidFill>
                <a:ea typeface="宋体" pitchFamily="2" charset="-122"/>
                <a:cs typeface="Arial" pitchFamily="34" charset="0"/>
              </a:rPr>
              <a:t>Figure 1:  </a:t>
            </a:r>
            <a:r>
              <a:rPr lang="en-US" altLang="zh-CN" sz="1600" dirty="0" smtClean="0"/>
              <a:t>The distribution of leukemia cells in mice thymus (top) and liver (bottom) was observed using two-photon fluorescence microscopy the first day after transplantation.</a:t>
            </a:r>
            <a:endParaRPr lang="en-US" altLang="zh-CN" sz="1600" dirty="0" smtClean="0">
              <a:solidFill>
                <a:srgbClr val="000000"/>
              </a:solidFill>
              <a:ea typeface="宋体" pitchFamily="2" charset="-122"/>
              <a:cs typeface="Arial" pitchFamily="34" charset="0"/>
            </a:endParaRPr>
          </a:p>
        </p:txBody>
      </p:sp>
      <p:pic>
        <p:nvPicPr>
          <p:cNvPr id="6" name="图片 5" descr="双光子-补充-2.tif"/>
          <p:cNvPicPr>
            <a:picLocks noChangeAspect="1"/>
          </p:cNvPicPr>
          <p:nvPr/>
        </p:nvPicPr>
        <p:blipFill>
          <a:blip r:embed="rId3" cstate="print"/>
          <a:srcRect t="34671"/>
          <a:stretch>
            <a:fillRect/>
          </a:stretch>
        </p:blipFill>
        <p:spPr>
          <a:xfrm>
            <a:off x="625154" y="1784648"/>
            <a:ext cx="5607692" cy="352779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127</Words>
  <Application>Microsoft Office PowerPoint</Application>
  <PresentationFormat>A4 纸张(210x297 毫米)</PresentationFormat>
  <Paragraphs>38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MSH</dc:creator>
  <cp:lastModifiedBy>MSH</cp:lastModifiedBy>
  <cp:revision>11</cp:revision>
  <dcterms:created xsi:type="dcterms:W3CDTF">2013-12-13T02:21:08Z</dcterms:created>
  <dcterms:modified xsi:type="dcterms:W3CDTF">2014-09-10T10:32:56Z</dcterms:modified>
</cp:coreProperties>
</file>